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20" d="100"/>
          <a:sy n="120" d="100"/>
        </p:scale>
        <p:origin x="-1332" y="-3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15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79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419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67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622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812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365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1327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406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982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77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C90025-3DF3-4073-AC30-7F7B948DD9EA}" type="datetimeFigureOut">
              <a:rPr lang="en-US" smtClean="0"/>
              <a:t>11/1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A49D9-D6FE-4AA6-B8A9-859C2178F5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725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microsoft.com/office/2007/relationships/hdphoto" Target="../media/hdphoto2.wdp"/><Relationship Id="rId5" Type="http://schemas.openxmlformats.org/officeDocument/2006/relationships/image" Target="../media/image4.jpeg"/><Relationship Id="rId10" Type="http://schemas.openxmlformats.org/officeDocument/2006/relationships/image" Target="../media/image8.jpeg"/><Relationship Id="rId4" Type="http://schemas.openxmlformats.org/officeDocument/2006/relationships/image" Target="../media/image3.jpeg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Rectangle 26"/>
          <p:cNvSpPr/>
          <p:nvPr/>
        </p:nvSpPr>
        <p:spPr>
          <a:xfrm>
            <a:off x="0" y="282134"/>
            <a:ext cx="91440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600" b="1" smtClean="0">
                <a:latin typeface="Arial" panose="020B0604020202020204" pitchFamily="34" charset="0"/>
                <a:cs typeface="Arial" panose="020B0604020202020204" pitchFamily="34" charset="0"/>
              </a:rPr>
              <a:t>S5 Fig.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48212" y="2328937"/>
            <a:ext cx="9052495" cy="2756247"/>
            <a:chOff x="48212" y="2135560"/>
            <a:chExt cx="9052495" cy="2756247"/>
          </a:xfrm>
        </p:grpSpPr>
        <p:pic>
          <p:nvPicPr>
            <p:cNvPr id="6" name="Picture 30" descr="C:\Users\Valentina\Desktop\mut hmz 1,5\Merge Scale Bar 800 Cutted 50x50 upper.jpg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40707" y="2432423"/>
              <a:ext cx="2158270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28" descr="C:\Users\Valentina\Desktop\mut hmz 1,5\Merge Scale Bar 800 Zoom.jpg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974930" y="4171807"/>
              <a:ext cx="719423" cy="72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Rectangle 7"/>
            <p:cNvSpPr/>
            <p:nvPr/>
          </p:nvSpPr>
          <p:spPr bwMode="auto">
            <a:xfrm>
              <a:off x="8463153" y="3401407"/>
              <a:ext cx="216000" cy="217488"/>
            </a:xfrm>
            <a:prstGeom prst="rect">
              <a:avLst/>
            </a:prstGeom>
            <a:noFill/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>
              <a:spLocks noChangeArrowheads="1"/>
            </p:cNvSpPr>
            <p:nvPr/>
          </p:nvSpPr>
          <p:spPr bwMode="auto">
            <a:xfrm rot="16200000">
              <a:off x="-882389" y="3379345"/>
              <a:ext cx="2122812" cy="261610"/>
            </a:xfrm>
            <a:prstGeom prst="rect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CH" altLang="en-US" sz="1100" b="1">
                  <a:solidFill>
                    <a:srgbClr val="92D050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CX36</a:t>
              </a:r>
              <a:r>
                <a:rPr lang="fr-CH" altLang="en-US" sz="1100" b="1">
                  <a:solidFill>
                    <a:srgbClr val="FF0000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 </a:t>
              </a:r>
              <a:r>
                <a:rPr lang="fr-CH" altLang="en-US" sz="1100" b="1">
                  <a:solidFill>
                    <a:srgbClr val="0070C0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6940707" y="2135560"/>
              <a:ext cx="2160000" cy="26161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IP-hCx36</a:t>
              </a:r>
              <a:r>
                <a:rPr lang="en-US" altLang="en-US" sz="1100" b="1" i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s3743123</a:t>
              </a:r>
              <a:endParaRPr lang="fr-CH" altLang="en-US" sz="1100" b="1" i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4738687" y="2135560"/>
              <a:ext cx="2160000" cy="26161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RIP-hCx36WT</a:t>
              </a:r>
              <a:endParaRPr lang="fr-CH" altLang="en-US" sz="1100" b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2" name="Rectangle 11"/>
            <p:cNvSpPr>
              <a:spLocks noChangeArrowheads="1"/>
            </p:cNvSpPr>
            <p:nvPr/>
          </p:nvSpPr>
          <p:spPr bwMode="auto">
            <a:xfrm>
              <a:off x="2548219" y="2135560"/>
              <a:ext cx="2160000" cy="26161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it-IT" alt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Ko</a:t>
              </a:r>
              <a:r>
                <a:rPr lang="en-US" alt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Cx36</a:t>
              </a:r>
              <a:endParaRPr lang="fr-CH" altLang="en-US" sz="1100" b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>
              <a:off x="357991" y="2135560"/>
              <a:ext cx="2160000" cy="26161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it-IT" altLang="en-US" sz="1100" b="1" dirty="0" smtClean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Endogenous m</a:t>
              </a:r>
              <a:r>
                <a:rPr lang="en-US" altLang="en-US" sz="1100" b="1" dirty="0">
                  <a:solidFill>
                    <a:schemeClr val="bg1"/>
                  </a:solidFill>
                  <a:latin typeface="Arial" panose="020B0604020202020204" pitchFamily="34" charset="0"/>
                  <a:ea typeface="MS PGothic" pitchFamily="34" charset="-128"/>
                  <a:cs typeface="Arial" panose="020B0604020202020204" pitchFamily="34" charset="0"/>
                </a:rPr>
                <a:t>Cx36</a:t>
              </a:r>
              <a:endParaRPr lang="fr-CH" altLang="en-US" sz="1100" b="1" dirty="0">
                <a:solidFill>
                  <a:schemeClr val="bg1"/>
                </a:solidFill>
                <a:latin typeface="Arial" panose="020B0604020202020204" pitchFamily="34" charset="0"/>
                <a:ea typeface="MS PGothic" pitchFamily="34" charset="-128"/>
                <a:cs typeface="Arial" panose="020B0604020202020204" pitchFamily="34" charset="0"/>
              </a:endParaRPr>
            </a:p>
          </p:txBody>
        </p:sp>
        <p:pic>
          <p:nvPicPr>
            <p:cNvPr id="15" name="Picture 31" descr="C:\Users\Valentina\Desktop\mut hmz 1,5\KO36 1,5\Merge Scale Bar 800 50x50.jpg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48219" y="2432423"/>
              <a:ext cx="2158270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" name="Picture 32" descr="C:\Users\Valentina\Desktop\mut hmz 1,5\KO36 1,5\Merge Scale Bar 800 5x5 zoom.jpg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87980" y="4171807"/>
              <a:ext cx="719424" cy="72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38" descr="C:\Users\Valentina\Desktop\cx\cnt\Untitled-1.jpg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7991" y="2432423"/>
              <a:ext cx="2160000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" name="Picture 39" descr="C:\Users\Valentina\Desktop\cx\cnt\Untitled-1 zoom.jpg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020" y="4171807"/>
              <a:ext cx="721972" cy="72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Rectangle 20"/>
            <p:cNvSpPr/>
            <p:nvPr/>
          </p:nvSpPr>
          <p:spPr bwMode="auto">
            <a:xfrm>
              <a:off x="1979712" y="3124156"/>
              <a:ext cx="193675" cy="217488"/>
            </a:xfrm>
            <a:prstGeom prst="rect">
              <a:avLst/>
            </a:prstGeom>
            <a:noFill/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6" name="Picture 2" descr="C:\Users\Valentina\Desktop\New folder wt\ONKY CX\Merge Crop Scale Bar 800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42682" y="2432423"/>
              <a:ext cx="2160000" cy="216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7" name="Picture 3" descr="C:\Users\Valentina\Desktop\New folder wt\ONKY CX\Merge Crop Scale Bar 800 zoom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78965" y="4171807"/>
              <a:ext cx="720000" cy="72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Rectangle 29"/>
            <p:cNvSpPr/>
            <p:nvPr/>
          </p:nvSpPr>
          <p:spPr bwMode="auto">
            <a:xfrm>
              <a:off x="3788789" y="3595663"/>
              <a:ext cx="193675" cy="217488"/>
            </a:xfrm>
            <a:prstGeom prst="rect">
              <a:avLst/>
            </a:prstGeom>
            <a:noFill/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/>
            <p:cNvSpPr/>
            <p:nvPr/>
          </p:nvSpPr>
          <p:spPr bwMode="auto">
            <a:xfrm>
              <a:off x="6056957" y="2731567"/>
              <a:ext cx="252000" cy="252000"/>
            </a:xfrm>
            <a:prstGeom prst="rect">
              <a:avLst/>
            </a:prstGeom>
            <a:noFill/>
            <a:ln w="952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66118" y="2391758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553411" y="2391758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738687" y="2391758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940707" y="2391758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155510" y="678346"/>
            <a:ext cx="8832981" cy="1094470"/>
            <a:chOff x="155510" y="136575"/>
            <a:chExt cx="8832981" cy="1094470"/>
          </a:xfrm>
        </p:grpSpPr>
        <p:sp>
          <p:nvSpPr>
            <p:cNvPr id="39" name="TextBox 38"/>
            <p:cNvSpPr txBox="1"/>
            <p:nvPr/>
          </p:nvSpPr>
          <p:spPr>
            <a:xfrm>
              <a:off x="179130" y="13657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" name="Group 43"/>
            <p:cNvGrpSpPr/>
            <p:nvPr/>
          </p:nvGrpSpPr>
          <p:grpSpPr>
            <a:xfrm>
              <a:off x="155510" y="548680"/>
              <a:ext cx="8832981" cy="142305"/>
              <a:chOff x="116632" y="1187624"/>
              <a:chExt cx="6624736" cy="189740"/>
            </a:xfrm>
          </p:grpSpPr>
          <p:cxnSp>
            <p:nvCxnSpPr>
              <p:cNvPr id="45" name="Straight Connector 44"/>
              <p:cNvCxnSpPr/>
              <p:nvPr/>
            </p:nvCxnSpPr>
            <p:spPr>
              <a:xfrm>
                <a:off x="116632" y="1282493"/>
                <a:ext cx="6624736" cy="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6" name="Group 45"/>
              <p:cNvGrpSpPr/>
              <p:nvPr/>
            </p:nvGrpSpPr>
            <p:grpSpPr>
              <a:xfrm>
                <a:off x="351706" y="1187624"/>
                <a:ext cx="6126460" cy="189740"/>
                <a:chOff x="836710" y="1577039"/>
                <a:chExt cx="6126460" cy="189740"/>
              </a:xfrm>
            </p:grpSpPr>
            <p:sp>
              <p:nvSpPr>
                <p:cNvPr id="47" name="Rectangle 46"/>
                <p:cNvSpPr/>
                <p:nvPr/>
              </p:nvSpPr>
              <p:spPr>
                <a:xfrm rot="10800000" flipV="1">
                  <a:off x="836710" y="1577040"/>
                  <a:ext cx="576065" cy="189737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IP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Rectangle 47"/>
                <p:cNvSpPr/>
                <p:nvPr/>
              </p:nvSpPr>
              <p:spPr>
                <a:xfrm rot="10800000" flipV="1">
                  <a:off x="1556792" y="1577040"/>
                  <a:ext cx="1268675" cy="18973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-globin intron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" name="Rectangle 48"/>
                <p:cNvSpPr/>
                <p:nvPr/>
              </p:nvSpPr>
              <p:spPr>
                <a:xfrm rot="10800000" flipV="1">
                  <a:off x="2996952" y="1577039"/>
                  <a:ext cx="2367880" cy="189739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x36 SNP </a:t>
                  </a:r>
                  <a:r>
                    <a:rPr lang="en-US" sz="12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s3743123 </a:t>
                  </a:r>
                </a:p>
              </p:txBody>
            </p:sp>
            <p:sp>
              <p:nvSpPr>
                <p:cNvPr id="50" name="Rectangle 49"/>
                <p:cNvSpPr/>
                <p:nvPr/>
              </p:nvSpPr>
              <p:spPr>
                <a:xfrm rot="10800000" flipV="1">
                  <a:off x="5517232" y="1577040"/>
                  <a:ext cx="1445938" cy="189739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-globin  polyA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51" name="Group 50"/>
            <p:cNvGrpSpPr/>
            <p:nvPr/>
          </p:nvGrpSpPr>
          <p:grpSpPr>
            <a:xfrm>
              <a:off x="155510" y="1088740"/>
              <a:ext cx="8832981" cy="142305"/>
              <a:chOff x="116632" y="1187624"/>
              <a:chExt cx="6624736" cy="189740"/>
            </a:xfrm>
          </p:grpSpPr>
          <p:cxnSp>
            <p:nvCxnSpPr>
              <p:cNvPr id="52" name="Straight Connector 51"/>
              <p:cNvCxnSpPr/>
              <p:nvPr/>
            </p:nvCxnSpPr>
            <p:spPr>
              <a:xfrm>
                <a:off x="116632" y="1282493"/>
                <a:ext cx="6624736" cy="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3" name="Group 52"/>
              <p:cNvGrpSpPr/>
              <p:nvPr/>
            </p:nvGrpSpPr>
            <p:grpSpPr>
              <a:xfrm>
                <a:off x="351706" y="1187624"/>
                <a:ext cx="6126460" cy="189740"/>
                <a:chOff x="836710" y="1577039"/>
                <a:chExt cx="6126460" cy="189740"/>
              </a:xfrm>
            </p:grpSpPr>
            <p:sp>
              <p:nvSpPr>
                <p:cNvPr id="54" name="Rectangle 53"/>
                <p:cNvSpPr/>
                <p:nvPr/>
              </p:nvSpPr>
              <p:spPr>
                <a:xfrm rot="10800000" flipV="1">
                  <a:off x="836710" y="1577040"/>
                  <a:ext cx="576065" cy="189737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IP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5" name="Rectangle 54"/>
                <p:cNvSpPr/>
                <p:nvPr/>
              </p:nvSpPr>
              <p:spPr>
                <a:xfrm rot="10800000" flipV="1">
                  <a:off x="1556792" y="1577040"/>
                  <a:ext cx="1268675" cy="18973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-globin intron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Rectangle 55"/>
                <p:cNvSpPr/>
                <p:nvPr/>
              </p:nvSpPr>
              <p:spPr>
                <a:xfrm rot="10800000" flipV="1">
                  <a:off x="2996952" y="1577039"/>
                  <a:ext cx="2367880" cy="189739"/>
                </a:xfrm>
                <a:prstGeom prst="rect">
                  <a:avLst/>
                </a:prstGeom>
                <a:solidFill>
                  <a:srgbClr val="C00000"/>
                </a:solidFill>
                <a:ln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Cx36 </a:t>
                  </a:r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wild-type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Rectangle 56"/>
                <p:cNvSpPr/>
                <p:nvPr/>
              </p:nvSpPr>
              <p:spPr>
                <a:xfrm rot="10800000" flipV="1">
                  <a:off x="5517232" y="1577040"/>
                  <a:ext cx="1445938" cy="189739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it-IT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-globin  polyA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cxnSp>
        <p:nvCxnSpPr>
          <p:cNvPr id="5" name="Straight Connector 4"/>
          <p:cNvCxnSpPr/>
          <p:nvPr/>
        </p:nvCxnSpPr>
        <p:spPr>
          <a:xfrm>
            <a:off x="2331749" y="4705201"/>
            <a:ext cx="126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89070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</TotalTime>
  <Words>32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tina</dc:creator>
  <cp:lastModifiedBy>Valentina</cp:lastModifiedBy>
  <cp:revision>23</cp:revision>
  <dcterms:created xsi:type="dcterms:W3CDTF">2015-02-07T11:25:57Z</dcterms:created>
  <dcterms:modified xsi:type="dcterms:W3CDTF">2015-11-15T15:41:25Z</dcterms:modified>
</cp:coreProperties>
</file>